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2057400" y="0"/>
            <a:ext cx="4749918" cy="5153439"/>
            <a:chOff x="1600200" y="381000"/>
            <a:chExt cx="4749918" cy="5153439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00200" y="381000"/>
              <a:ext cx="4749918" cy="51534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3049858" y="4495800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1</a:t>
              </a:r>
              <a:endParaRPr lang="en-U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059383" y="3920609"/>
              <a:ext cx="6109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solidFill>
                    <a:srgbClr val="29992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2 </a:t>
              </a:r>
              <a:endParaRPr lang="en-US" b="1" dirty="0">
                <a:solidFill>
                  <a:srgbClr val="29992C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089509" y="2156936"/>
              <a:ext cx="6490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3</a:t>
              </a:r>
              <a:endPara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386160" y="1066800"/>
              <a:ext cx="5961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4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914400" y="5278467"/>
            <a:ext cx="6781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ea typeface="Times New Roman"/>
              </a:rPr>
              <a:t>Additional file </a:t>
            </a:r>
            <a:r>
              <a:rPr lang="en-US" sz="1200" b="1" dirty="0" smtClean="0">
                <a:latin typeface="Times New Roman"/>
                <a:ea typeface="Times New Roman"/>
              </a:rPr>
              <a:t>4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uality control us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mponen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RNA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generated from successive sub-apica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nod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bioenergy sorghum R.07020. Samples from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oungest subapical internod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Int1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in red and successive older internod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2, Int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en, blue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black, respectively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replicates represented by circles filled with similar color are clustered together. </a:t>
            </a:r>
          </a:p>
        </p:txBody>
      </p:sp>
    </p:spTree>
    <p:extLst>
      <p:ext uri="{BB962C8B-B14F-4D97-AF65-F5344CB8AC3E}">
        <p14:creationId xmlns:p14="http://schemas.microsoft.com/office/powerpoint/2010/main" xmlns="" val="25532661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72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4:27Z</dcterms:modified>
</cp:coreProperties>
</file>